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07200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EB1DA2-4798-4089-B7C1-5EFCA9BE116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5079AF-7BFF-4613-8DB2-658937489A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DFC720-3098-49E2-B825-5C1EABB9C19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269BDD-6CAB-408B-AED5-285F3272D8C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5FEF29-E366-4730-9A72-6EDEA77C6F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27F8BC-A92D-406D-9403-65E8590A02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FF645E-8AF0-4B5D-B248-8236492982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2D7B48-C0B7-421D-A712-00DFCE99FB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242662-9831-4691-8526-610ADE2E3E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F399E0-49BF-44C3-BE2D-F41928D12B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110FD1-BC96-4123-A222-D069C00833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8BA5E6-E780-4470-83FD-1AA2A01C9E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31A140-CA28-41BC-AB37-0611A64F3DB7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318960" y="1222200"/>
            <a:ext cx="3289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TABLE S1. List of Accession numbe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3"/>
          <p:cNvSpPr/>
          <p:nvPr/>
        </p:nvSpPr>
        <p:spPr>
          <a:xfrm>
            <a:off x="1346040" y="1623960"/>
            <a:ext cx="578160" cy="16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anchorCtr="1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Sor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4"/>
          <p:cNvSpPr/>
          <p:nvPr/>
        </p:nvSpPr>
        <p:spPr>
          <a:xfrm>
            <a:off x="2157480" y="1623960"/>
            <a:ext cx="1844640" cy="16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anchorCtr="1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Nam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5"/>
          <p:cNvSpPr/>
          <p:nvPr/>
        </p:nvSpPr>
        <p:spPr>
          <a:xfrm>
            <a:off x="571680" y="1606680"/>
            <a:ext cx="6119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6"/>
          <p:cNvSpPr/>
          <p:nvPr/>
        </p:nvSpPr>
        <p:spPr>
          <a:xfrm>
            <a:off x="571680" y="1806480"/>
            <a:ext cx="6119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7"/>
          <p:cNvSpPr/>
          <p:nvPr/>
        </p:nvSpPr>
        <p:spPr>
          <a:xfrm>
            <a:off x="571680" y="4022640"/>
            <a:ext cx="6119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7"/>
          <p:cNvSpPr/>
          <p:nvPr/>
        </p:nvSpPr>
        <p:spPr>
          <a:xfrm>
            <a:off x="1064160" y="1838160"/>
            <a:ext cx="1143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enomic Scaffol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21"/>
          <p:cNvSpPr/>
          <p:nvPr/>
        </p:nvSpPr>
        <p:spPr>
          <a:xfrm>
            <a:off x="2760120" y="1838160"/>
            <a:ext cx="25552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m_scaf1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0903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m_scaf7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09038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m_scaf27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09034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4"/>
          <p:cNvSpPr/>
          <p:nvPr/>
        </p:nvSpPr>
        <p:spPr>
          <a:xfrm>
            <a:off x="3943440" y="1622520"/>
            <a:ext cx="1844640" cy="16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anchorCtr="1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Accession numb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7"/>
          <p:cNvSpPr/>
          <p:nvPr/>
        </p:nvSpPr>
        <p:spPr>
          <a:xfrm>
            <a:off x="1380240" y="2338560"/>
            <a:ext cx="511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cDN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21"/>
          <p:cNvSpPr/>
          <p:nvPr/>
        </p:nvSpPr>
        <p:spPr>
          <a:xfrm>
            <a:off x="2748960" y="2338560"/>
            <a:ext cx="2885760" cy="11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mEcR-A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8711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mEcR-B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M_00104386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mE75-A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B02490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mE75-B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M_00111261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mE75-C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F33255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HR3-A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M_00104354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HR3-B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B02490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7"/>
          <p:cNvSpPr/>
          <p:nvPr/>
        </p:nvSpPr>
        <p:spPr>
          <a:xfrm>
            <a:off x="1344240" y="3478320"/>
            <a:ext cx="58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rote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21"/>
          <p:cNvSpPr/>
          <p:nvPr/>
        </p:nvSpPr>
        <p:spPr>
          <a:xfrm>
            <a:off x="2733840" y="3478320"/>
            <a:ext cx="25963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mEcR-A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AA2228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mEcR-B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4988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mUS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497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29T11:11:12Z</dcterms:created>
  <dc:creator>白井博之</dc:creator>
  <dc:description/>
  <dc:language>en-US</dc:language>
  <cp:lastModifiedBy> </cp:lastModifiedBy>
  <dcterms:modified xsi:type="dcterms:W3CDTF">2012-05-17T06:11:51Z</dcterms:modified>
  <cp:revision>22</cp:revision>
  <dc:subject/>
  <dc:title>スライド 1</dc:title>
</cp:coreProperties>
</file>